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EEF3"/>
    <a:srgbClr val="3184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25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01605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10978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73810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74794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12705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77568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828370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95117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49198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33002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816368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C23B15-BBB9-42AF-BD05-C0BE6E5060CF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A2396-03DA-4BBE-8B1D-3B3EF36D51E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82861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619028"/>
              </p:ext>
            </p:extLst>
          </p:nvPr>
        </p:nvGraphicFramePr>
        <p:xfrm>
          <a:off x="193572" y="212299"/>
          <a:ext cx="9378416" cy="2496774"/>
        </p:xfrm>
        <a:graphic>
          <a:graphicData uri="http://schemas.openxmlformats.org/drawingml/2006/table">
            <a:tbl>
              <a:tblPr/>
              <a:tblGrid>
                <a:gridCol w="81491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4886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6162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1151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1080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2708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30849">
                <a:tc gridSpan="2">
                  <a:txBody>
                    <a:bodyPr/>
                    <a:lstStyle/>
                    <a:p>
                      <a:pPr algn="l" fontAlgn="b"/>
                      <a:endParaRPr lang="en-IE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I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1698">
                <a:tc>
                  <a:txBody>
                    <a:bodyPr/>
                    <a:lstStyle/>
                    <a:p>
                      <a:pPr algn="l" fontAlgn="ctr"/>
                      <a:r>
                        <a:rPr lang="en-IE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ature MicroRNA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ouse Sequence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Rat Sequence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Human Sequence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onserved MicroRNA? 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o. of conserved mRNA targets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3535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GAUAUGAUGACUGAUUACCUGAGA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o annotation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o annotation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ouse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673-5p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CUCACAGCUCUGGUCCUUGGAG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CUCACAGCUCCGGUCCUUGGAG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o annotation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In Rodents 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282 M/R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206-3p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GAAUGUAAGGAAGUGUGUGG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UGGAAUGUAAGGAAGUGUGUGG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GAAUGUAAGGAAGUGUGUGG (hsa-miR-206)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18 (M/R/H) 222 (M/R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1964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CCGACUUCUGGGCUCCGGCUUU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o annotation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o annotation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ouse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5121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GCUUGUGAUGAGACAUCUCC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o annotation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o annotation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ouse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122-5p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GAGUGUGACAAUGGUGUUUG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GAGUGUGACAAUGGUGUUUG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GAGUGUGACAAUGGUGUUUG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62 (M/R) 34 (M/R/H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362-3p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ACACACCUGUUCAAGGAUUCA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ACACACCUGUUCAAGGAUUCA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ACACACCUAUUCAAGGAUUCA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Yes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55 (M/R/H) 207 (M/R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369-5p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GAUCGACCGUGUUAUAUUCGC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GAUCGACCGUGUUAUAUUCGC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GAUCGACCGUGUUAUAUUCGC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6 (M/R) 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182-5p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UUGGCAAUGGUAGAACUCACAC</a:t>
                      </a:r>
                      <a:r>
                        <a:rPr lang="en-IE" sz="700" b="1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CG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UUGGCAAUGGUAGAACUCACACCG (rno-miR-182)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UUGGCAAUGGUAGAACUCACAC</a:t>
                      </a:r>
                      <a:r>
                        <a:rPr lang="en-IE" sz="700" b="1" i="0" u="sng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</a:t>
                      </a:r>
                      <a:endParaRPr lang="en-IE" sz="7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72 (M/R/H) 327 (M/R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183-5p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AUGGCACUGGUAGAAUUCACU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AUGGCACUGGUAGAAUUCACU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AUGGCACUGGUAGAAUUCACU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49 (M/R/H) 118 (M/R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187-5p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GGCUACAACACAGGACC</a:t>
                      </a:r>
                      <a:r>
                        <a:rPr lang="en-IE" sz="700" b="1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CGGG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GGCUACAACACAGGACC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GGCUACAACACAGGACC</a:t>
                      </a:r>
                      <a:r>
                        <a:rPr lang="en-IE" sz="700" b="1" i="0" u="sng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CGGGC</a:t>
                      </a:r>
                      <a:endParaRPr lang="en-IE" sz="7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equence differences 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22 (M/R/H)</a:t>
                      </a:r>
                      <a:r>
                        <a:rPr lang="en-IE" sz="7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149 (M/R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187-3p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CGUGUCUUGUGUUGCAGCCGG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CGUGUCUUGUGUUGCAGCCGG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CGUGUCUUGUGUUGCAGCCGG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2 (M/R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137-3p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UAUUGCUUAAGAAUACGCGUAG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UAUUGCUUAAGAAUACGCGUAG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UAUUGCUUAAGAAUACGCGUAG (has-mir-137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Yes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98 (M/R/H) 303 (M/R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1a-3p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GAAUGUAAAGAAGU</a:t>
                      </a:r>
                      <a:r>
                        <a:rPr lang="en-IE" sz="700" b="1" i="0" u="sng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UAU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GAAUGUAAAGAAGU</a:t>
                      </a:r>
                      <a:r>
                        <a:rPr lang="en-IE" sz="700" b="1" i="0" u="sng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UAU (rno-mir-1-3p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UGGAAUGUAAAGAAGUAUGUAU (has-miR-1-3p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Human/mouse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16 (M/R/H) 235 (M/R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iR-219a-2-3p</a:t>
                      </a: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GAAUUGUGGCUGGACAUCUGU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GAAUUGUGGCUGGACAUCUGU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I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GAAUUGUGGCUGGACAUCUGU</a:t>
                      </a:r>
                    </a:p>
                  </a:txBody>
                  <a:tcPr marL="4332" marR="4332" marT="43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Yes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E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9 (M/R/H)</a:t>
                      </a:r>
                      <a:r>
                        <a:rPr lang="en-IE" sz="7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99 (M/R)</a:t>
                      </a:r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30849">
                <a:tc>
                  <a:txBody>
                    <a:bodyPr/>
                    <a:lstStyle/>
                    <a:p>
                      <a:pPr algn="l" fontAlgn="b"/>
                      <a:endParaRPr lang="en-IE" sz="7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E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32" marR="4332" marT="433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41668" y="103032"/>
            <a:ext cx="65939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solidFill>
                  <a:srgbClr val="000000"/>
                </a:solidFill>
                <a:cs typeface="Times New Roman" panose="02020603050405020304" pitchFamily="18" charset="0"/>
              </a:rPr>
              <a:t>Supplemental </a:t>
            </a:r>
            <a:r>
              <a:rPr lang="en-IE" sz="1200" b="1" dirty="0">
                <a:solidFill>
                  <a:srgbClr val="000000"/>
                </a:solidFill>
                <a:cs typeface="Times New Roman" panose="02020603050405020304" pitchFamily="18" charset="0"/>
              </a:rPr>
              <a:t>T</a:t>
            </a:r>
            <a:r>
              <a:rPr lang="en-IE" sz="1200" b="1" dirty="0" smtClean="0">
                <a:solidFill>
                  <a:srgbClr val="000000"/>
                </a:solidFill>
                <a:cs typeface="Times New Roman" panose="02020603050405020304" pitchFamily="18" charset="0"/>
              </a:rPr>
              <a:t>able </a:t>
            </a:r>
            <a:r>
              <a:rPr lang="en-IE" sz="1200" b="1" dirty="0" smtClean="0">
                <a:solidFill>
                  <a:srgbClr val="000000"/>
                </a:solidFill>
                <a:cs typeface="Times New Roman" panose="02020603050405020304" pitchFamily="18" charset="0"/>
              </a:rPr>
              <a:t>2. </a:t>
            </a:r>
            <a:r>
              <a:rPr lang="en-IE" sz="1200" b="1" dirty="0">
                <a:solidFill>
                  <a:srgbClr val="000000"/>
                </a:solidFill>
                <a:cs typeface="Times New Roman" panose="02020603050405020304" pitchFamily="18" charset="0"/>
              </a:rPr>
              <a:t>Selected microRNA for </a:t>
            </a:r>
            <a:r>
              <a:rPr lang="en-IE" sz="1200" b="1" dirty="0" err="1" smtClean="0">
                <a:solidFill>
                  <a:srgbClr val="000000"/>
                </a:solidFill>
                <a:cs typeface="Times New Roman" panose="02020603050405020304" pitchFamily="18" charset="0"/>
              </a:rPr>
              <a:t>qRT</a:t>
            </a:r>
            <a:r>
              <a:rPr lang="en-IE" sz="1200" b="1" dirty="0">
                <a:solidFill>
                  <a:srgbClr val="000000"/>
                </a:solidFill>
                <a:cs typeface="Times New Roman" panose="02020603050405020304" pitchFamily="18" charset="0"/>
              </a:rPr>
              <a:t>-</a:t>
            </a:r>
            <a:r>
              <a:rPr lang="en-IE" sz="1200" b="1" dirty="0" smtClean="0">
                <a:solidFill>
                  <a:srgbClr val="000000"/>
                </a:solidFill>
                <a:cs typeface="Times New Roman" panose="02020603050405020304" pitchFamily="18" charset="0"/>
              </a:rPr>
              <a:t>PCR Validation</a:t>
            </a:r>
            <a:endParaRPr lang="en-IE" sz="1200" b="1" dirty="0">
              <a:solidFill>
                <a:srgbClr val="000000"/>
              </a:solidFill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60308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5</TotalTime>
  <Words>210</Words>
  <Application>Microsoft Office PowerPoint</Application>
  <PresentationFormat>A4 Paper (210x297 mm)</PresentationFormat>
  <Paragraphs>10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</dc:creator>
  <cp:lastModifiedBy>Hoban, Alan</cp:lastModifiedBy>
  <cp:revision>32</cp:revision>
  <cp:lastPrinted>2016-06-15T16:57:18Z</cp:lastPrinted>
  <dcterms:created xsi:type="dcterms:W3CDTF">2016-06-12T14:09:46Z</dcterms:created>
  <dcterms:modified xsi:type="dcterms:W3CDTF">2017-01-14T12:57:11Z</dcterms:modified>
</cp:coreProperties>
</file>